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7" r:id="rId3"/>
    <p:sldId id="258" r:id="rId4"/>
    <p:sldId id="259" r:id="rId5"/>
    <p:sldId id="260" r:id="rId6"/>
    <p:sldId id="261" r:id="rId7"/>
    <p:sldId id="262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0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017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13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359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07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741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873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717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386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702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372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134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A616C-0E08-4C78-AF20-A431A6464583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88239C-4E2E-410C-B22A-C9DACAA4C7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681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09800" y="1905000"/>
            <a:ext cx="40386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r. Suzuki </a:t>
            </a:r>
          </a:p>
          <a:p>
            <a:r>
              <a:rPr lang="en-US" dirty="0" err="1" smtClean="0"/>
              <a:t>Tofms</a:t>
            </a:r>
            <a:r>
              <a:rPr lang="en-US" dirty="0" smtClean="0"/>
              <a:t> </a:t>
            </a:r>
            <a:r>
              <a:rPr lang="en-US" dirty="0" smtClean="0"/>
              <a:t>Mode – Positive and </a:t>
            </a:r>
            <a:r>
              <a:rPr lang="en-US" dirty="0" smtClean="0"/>
              <a:t>Negative</a:t>
            </a:r>
          </a:p>
          <a:p>
            <a:r>
              <a:rPr lang="en-US" dirty="0"/>
              <a:t>Lung tissue Samples – 26</a:t>
            </a:r>
          </a:p>
          <a:p>
            <a:r>
              <a:rPr lang="en-US" dirty="0" smtClean="0"/>
              <a:t>PAH 8 weeks- 7</a:t>
            </a:r>
          </a:p>
          <a:p>
            <a:r>
              <a:rPr lang="en-US" dirty="0" smtClean="0"/>
              <a:t>PAH 35 weeks- 6</a:t>
            </a:r>
          </a:p>
          <a:p>
            <a:r>
              <a:rPr lang="en-US" dirty="0" smtClean="0"/>
              <a:t>Control 8 weeks- 7</a:t>
            </a:r>
          </a:p>
          <a:p>
            <a:r>
              <a:rPr lang="en-US" dirty="0" smtClean="0"/>
              <a:t>Control 35 weeks- 6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36245512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609600"/>
            <a:ext cx="3581400" cy="3429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200" y="1110449"/>
            <a:ext cx="4267200" cy="2895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4600" y="228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H 35 weeks vs Control 35 weeks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85800" y="2286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itive mode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685800" y="4343400"/>
            <a:ext cx="76962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3: </a:t>
            </a:r>
            <a:r>
              <a:rPr lang="en-US" dirty="0"/>
              <a:t>a)Volcano plot in Positive ionization mode for 2 groups-  </a:t>
            </a:r>
            <a:r>
              <a:rPr lang="en-US" dirty="0" smtClean="0"/>
              <a:t>PAH 35 weeks </a:t>
            </a:r>
            <a:r>
              <a:rPr lang="en-US" dirty="0"/>
              <a:t>vs </a:t>
            </a:r>
            <a:r>
              <a:rPr lang="en-US" dirty="0" smtClean="0"/>
              <a:t>control 35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Positive mode Ionization with 95% confidence region for </a:t>
            </a:r>
            <a:r>
              <a:rPr lang="en-US" dirty="0" smtClean="0"/>
              <a:t>PAH 35 weeks </a:t>
            </a:r>
            <a:r>
              <a:rPr lang="en-US" dirty="0"/>
              <a:t>(Group1) versus </a:t>
            </a:r>
            <a:r>
              <a:rPr lang="en-US" dirty="0" smtClean="0"/>
              <a:t>Control 35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5265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533400"/>
            <a:ext cx="4114800" cy="31242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044" y="762000"/>
            <a:ext cx="4150311" cy="3124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4600" y="228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H 35 weeks vs Control 35 weeks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52400" y="228600"/>
            <a:ext cx="198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 mode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685800" y="4343400"/>
            <a:ext cx="76962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4</a:t>
            </a:r>
            <a:r>
              <a:rPr lang="en-US" dirty="0" smtClean="0"/>
              <a:t>: </a:t>
            </a:r>
            <a:r>
              <a:rPr lang="en-US" dirty="0"/>
              <a:t>a)Volcano plot in </a:t>
            </a:r>
            <a:r>
              <a:rPr lang="en-US" dirty="0" smtClean="0"/>
              <a:t>Negative </a:t>
            </a:r>
            <a:r>
              <a:rPr lang="en-US" dirty="0"/>
              <a:t>ionization mode for 2 groups-  </a:t>
            </a:r>
            <a:r>
              <a:rPr lang="en-US" dirty="0" smtClean="0"/>
              <a:t>PAH 35 weeks </a:t>
            </a:r>
            <a:r>
              <a:rPr lang="en-US" dirty="0"/>
              <a:t>vs </a:t>
            </a:r>
            <a:r>
              <a:rPr lang="en-US" dirty="0" smtClean="0"/>
              <a:t>control 35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</a:t>
            </a:r>
            <a:r>
              <a:rPr lang="en-US" dirty="0" smtClean="0"/>
              <a:t>Negative </a:t>
            </a:r>
            <a:r>
              <a:rPr lang="en-US" dirty="0"/>
              <a:t>mode Ionization with 95% confidence region for </a:t>
            </a:r>
            <a:r>
              <a:rPr lang="en-US" dirty="0" smtClean="0"/>
              <a:t>PAH 35 weeks </a:t>
            </a:r>
            <a:r>
              <a:rPr lang="en-US" dirty="0"/>
              <a:t>(Group1) versus </a:t>
            </a:r>
            <a:r>
              <a:rPr lang="en-US" dirty="0" smtClean="0"/>
              <a:t>Control 35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89690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890" y="838200"/>
            <a:ext cx="4218709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000" y="1143000"/>
            <a:ext cx="3657600" cy="2514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4600" y="228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H 8 weeks vs PAH 35 weeks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85800" y="22860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itive mode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685800" y="4343400"/>
            <a:ext cx="76962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5: </a:t>
            </a:r>
            <a:r>
              <a:rPr lang="en-US" dirty="0"/>
              <a:t>a)Volcano plot in Positive ionization mode for 2 groups-  </a:t>
            </a:r>
            <a:r>
              <a:rPr lang="en-US" dirty="0" smtClean="0"/>
              <a:t>PAH 35 weeks vs PAH 8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Positive mode Ionization with 95% confidence region for </a:t>
            </a:r>
            <a:r>
              <a:rPr lang="en-US" dirty="0" smtClean="0"/>
              <a:t>PAH 35 weeks </a:t>
            </a:r>
            <a:r>
              <a:rPr lang="en-US" dirty="0"/>
              <a:t>(Group1) versus </a:t>
            </a:r>
            <a:r>
              <a:rPr lang="en-US" dirty="0" smtClean="0"/>
              <a:t>PAH 8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000703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685800"/>
            <a:ext cx="3505200" cy="29718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5400" y="914400"/>
            <a:ext cx="3124200" cy="25908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14600" y="228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H 8 weeks vs PAH 35 weeks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09600" y="30480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 mod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685800" y="4343400"/>
            <a:ext cx="76962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6</a:t>
            </a:r>
            <a:r>
              <a:rPr lang="en-US" dirty="0" smtClean="0"/>
              <a:t>: </a:t>
            </a:r>
            <a:r>
              <a:rPr lang="en-US" dirty="0"/>
              <a:t>a)Volcano plot in </a:t>
            </a:r>
            <a:r>
              <a:rPr lang="en-US" dirty="0" smtClean="0"/>
              <a:t>Negative </a:t>
            </a:r>
            <a:r>
              <a:rPr lang="en-US" dirty="0"/>
              <a:t>ionization mode for 2 groups-  </a:t>
            </a:r>
            <a:r>
              <a:rPr lang="en-US" dirty="0" smtClean="0"/>
              <a:t>PAH 35 weeks vs PAH 8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</a:t>
            </a:r>
            <a:r>
              <a:rPr lang="en-US" dirty="0" smtClean="0"/>
              <a:t>Negative </a:t>
            </a:r>
            <a:r>
              <a:rPr lang="en-US" dirty="0"/>
              <a:t>mode Ionization with 95% confidence region for </a:t>
            </a:r>
            <a:r>
              <a:rPr lang="en-US" dirty="0" smtClean="0"/>
              <a:t>PAH 35 weeks </a:t>
            </a:r>
            <a:r>
              <a:rPr lang="en-US" dirty="0"/>
              <a:t>(Group1) versus </a:t>
            </a:r>
            <a:r>
              <a:rPr lang="en-US" dirty="0" smtClean="0"/>
              <a:t>PAH 8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125846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685800"/>
            <a:ext cx="3962400" cy="3429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8200" y="990600"/>
            <a:ext cx="3710126" cy="2514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62200" y="457200"/>
            <a:ext cx="3581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ntrol 8 weeks vs control 35 week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33400" y="2286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itive Mode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685800" y="4343400"/>
            <a:ext cx="7924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7: </a:t>
            </a:r>
            <a:r>
              <a:rPr lang="en-US" dirty="0"/>
              <a:t>a)Volcano plot in Positive ionization mode for 2 groups-  </a:t>
            </a:r>
            <a:r>
              <a:rPr lang="en-US" dirty="0" smtClean="0"/>
              <a:t>Control 35 weeks </a:t>
            </a:r>
            <a:r>
              <a:rPr lang="en-US" dirty="0"/>
              <a:t>vs </a:t>
            </a:r>
            <a:r>
              <a:rPr lang="en-US" dirty="0" smtClean="0"/>
              <a:t>control 8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Positive mode Ionization with 95% confidence region for </a:t>
            </a:r>
            <a:r>
              <a:rPr lang="en-US" dirty="0" smtClean="0"/>
              <a:t>control 35 weeks </a:t>
            </a:r>
            <a:r>
              <a:rPr lang="en-US" dirty="0"/>
              <a:t>(Group1) versus </a:t>
            </a:r>
            <a:r>
              <a:rPr lang="en-US" dirty="0" smtClean="0"/>
              <a:t>Control 8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9519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685800"/>
            <a:ext cx="4038600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000" y="838200"/>
            <a:ext cx="3762375" cy="25908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62200" y="457200"/>
            <a:ext cx="3581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ontrol 8 weeks vs control 35 week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28600" y="152400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 Mode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685800" y="4343400"/>
            <a:ext cx="7924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8</a:t>
            </a:r>
            <a:r>
              <a:rPr lang="en-US" dirty="0" smtClean="0"/>
              <a:t>: </a:t>
            </a:r>
            <a:r>
              <a:rPr lang="en-US" dirty="0"/>
              <a:t>a)Volcano plot in </a:t>
            </a:r>
            <a:r>
              <a:rPr lang="en-US" dirty="0" smtClean="0"/>
              <a:t>Negative </a:t>
            </a:r>
            <a:r>
              <a:rPr lang="en-US" dirty="0"/>
              <a:t>ionization mode for 2 groups-  </a:t>
            </a:r>
            <a:r>
              <a:rPr lang="en-US" dirty="0" smtClean="0"/>
              <a:t>Control 35 weeks </a:t>
            </a:r>
            <a:r>
              <a:rPr lang="en-US" dirty="0"/>
              <a:t>vs </a:t>
            </a:r>
            <a:r>
              <a:rPr lang="en-US" dirty="0" smtClean="0"/>
              <a:t>control 8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</a:t>
            </a:r>
            <a:r>
              <a:rPr lang="en-US" dirty="0" smtClean="0"/>
              <a:t>Negative </a:t>
            </a:r>
            <a:r>
              <a:rPr lang="en-US" dirty="0"/>
              <a:t>mode Ionization with 95% confidence region for </a:t>
            </a:r>
            <a:r>
              <a:rPr lang="en-US" dirty="0" smtClean="0"/>
              <a:t>control 35 weeks </a:t>
            </a:r>
            <a:r>
              <a:rPr lang="en-US" dirty="0"/>
              <a:t>(Group1) versus </a:t>
            </a:r>
            <a:r>
              <a:rPr lang="en-US" dirty="0" smtClean="0"/>
              <a:t>Control 8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1427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252413"/>
            <a:ext cx="7848600" cy="6353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209800" y="495300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N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352800" y="2819400"/>
            <a:ext cx="2590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Metmix</a:t>
            </a:r>
            <a:r>
              <a:rPr lang="en-US" dirty="0" smtClean="0"/>
              <a:t> – within 5 ppm error range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362200" y="685800"/>
            <a:ext cx="1371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ater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429000" y="252413"/>
            <a:ext cx="220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itive Mode- Before the ru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86541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252412"/>
            <a:ext cx="7848600" cy="6353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743200" y="381000"/>
            <a:ext cx="1066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QC overlays- Positive mod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1916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493" y="441156"/>
            <a:ext cx="8534400" cy="613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09800" y="495300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352800" y="2819400"/>
            <a:ext cx="2286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Metmix</a:t>
            </a:r>
            <a:r>
              <a:rPr lang="en-US" dirty="0" smtClean="0"/>
              <a:t> – within 5 ppm error range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362200" y="685800"/>
            <a:ext cx="1371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ater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429000" y="252413"/>
            <a:ext cx="220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itive Mode- After the ru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38640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533400"/>
            <a:ext cx="8000999" cy="6072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09800" y="495300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352800" y="2819400"/>
            <a:ext cx="220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Metmix</a:t>
            </a:r>
            <a:r>
              <a:rPr lang="en-US" dirty="0" smtClean="0"/>
              <a:t> – within 5 ppm error range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362200" y="685800"/>
            <a:ext cx="1371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ater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429000" y="252413"/>
            <a:ext cx="220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 Mode- Before the ru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74366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714" y="252413"/>
            <a:ext cx="8381999" cy="6353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209800" y="495300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352800" y="2819400"/>
            <a:ext cx="2133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Metmix</a:t>
            </a:r>
            <a:r>
              <a:rPr lang="en-US" dirty="0" smtClean="0"/>
              <a:t> – within 5 ppm error range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362200" y="685800"/>
            <a:ext cx="1371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ater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429000" y="252413"/>
            <a:ext cx="220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 Mode- After the ru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67057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381000"/>
            <a:ext cx="7924800" cy="6224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276600" y="304800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QC overlays- Negative mod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0952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4600" y="228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H 8 weeks vs Control 8 weeks 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762000" y="228600"/>
            <a:ext cx="16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itive Mode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838200"/>
            <a:ext cx="4038600" cy="33528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1143000"/>
            <a:ext cx="3886200" cy="25908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09600" y="4306163"/>
            <a:ext cx="77724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1: a)Volcano plot in Positive ionization mode for 2 groups-  </a:t>
            </a:r>
            <a:r>
              <a:rPr lang="en-US" dirty="0" smtClean="0"/>
              <a:t>PAH 8 weeks </a:t>
            </a:r>
            <a:r>
              <a:rPr lang="en-US" dirty="0"/>
              <a:t>vs </a:t>
            </a:r>
            <a:r>
              <a:rPr lang="en-US" dirty="0" smtClean="0"/>
              <a:t>control 8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Positive mode Ionization with 95% confidence region for </a:t>
            </a:r>
            <a:r>
              <a:rPr lang="en-US" dirty="0" smtClean="0"/>
              <a:t>PAH 8 weeks </a:t>
            </a:r>
            <a:r>
              <a:rPr lang="en-US" dirty="0"/>
              <a:t>(Group1) versus </a:t>
            </a:r>
            <a:r>
              <a:rPr lang="en-US" dirty="0" smtClean="0"/>
              <a:t>Control 8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47069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14600" y="228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H 8 weeks vs Control 8 weeks 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545237" y="2286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egative Mode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762000"/>
            <a:ext cx="3810000" cy="3429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1295400"/>
            <a:ext cx="4127500" cy="2362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794550" y="4191000"/>
            <a:ext cx="781604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2: </a:t>
            </a:r>
            <a:r>
              <a:rPr lang="en-US" dirty="0"/>
              <a:t>a)Volcano plot in </a:t>
            </a:r>
            <a:r>
              <a:rPr lang="en-US" dirty="0" smtClean="0"/>
              <a:t>Negative </a:t>
            </a:r>
            <a:r>
              <a:rPr lang="en-US" dirty="0"/>
              <a:t>ionization mode for 2 groups-  </a:t>
            </a:r>
            <a:r>
              <a:rPr lang="en-US" dirty="0" smtClean="0"/>
              <a:t>PAH 8 weeks </a:t>
            </a:r>
            <a:r>
              <a:rPr lang="en-US" dirty="0"/>
              <a:t>vs </a:t>
            </a:r>
            <a:r>
              <a:rPr lang="en-US" dirty="0" smtClean="0"/>
              <a:t>control 8 weeks. </a:t>
            </a:r>
            <a:r>
              <a:rPr lang="en-US" dirty="0"/>
              <a:t>Each feature is represented as dot plotted as a function of fold change on X- axis and statistical significance - p- value on Y- axis. The pink dots represents selected features with a p value of ≤ 0.05 and a fold change of &gt; or &lt; 2. b) PLS-DA plot for </a:t>
            </a:r>
            <a:r>
              <a:rPr lang="en-US" dirty="0" smtClean="0"/>
              <a:t>Negative </a:t>
            </a:r>
            <a:r>
              <a:rPr lang="en-US" dirty="0"/>
              <a:t>mode Ionization with 95% confidence region for </a:t>
            </a:r>
            <a:r>
              <a:rPr lang="en-US" dirty="0" smtClean="0"/>
              <a:t>PAH 8 weeks </a:t>
            </a:r>
            <a:r>
              <a:rPr lang="en-US" dirty="0"/>
              <a:t>(Group1) versus </a:t>
            </a:r>
            <a:r>
              <a:rPr lang="en-US" dirty="0" smtClean="0"/>
              <a:t>Control 8 weeks(Group </a:t>
            </a:r>
            <a:r>
              <a:rPr lang="en-US" dirty="0"/>
              <a:t>0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0962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26</Words>
  <Application>Microsoft Office PowerPoint</Application>
  <PresentationFormat>On-screen Show (4:3)</PresentationFormat>
  <Paragraphs>49</Paragraphs>
  <Slides>1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randeep Gill</dc:creator>
  <cp:lastModifiedBy>Kirandeep Gill</cp:lastModifiedBy>
  <cp:revision>7</cp:revision>
  <dcterms:created xsi:type="dcterms:W3CDTF">2016-02-29T20:06:46Z</dcterms:created>
  <dcterms:modified xsi:type="dcterms:W3CDTF">2016-03-03T19:51:11Z</dcterms:modified>
</cp:coreProperties>
</file>